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63" r:id="rId3"/>
    <p:sldId id="256" r:id="rId4"/>
    <p:sldId id="257" r:id="rId5"/>
    <p:sldId id="258" r:id="rId6"/>
    <p:sldId id="259" r:id="rId7"/>
    <p:sldId id="260" r:id="rId8"/>
    <p:sldId id="261" r:id="rId9"/>
    <p:sldId id="262" r:id="rId10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75" d="100"/>
          <a:sy n="75" d="100"/>
        </p:scale>
        <p:origin x="-448" y="6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4A9B150-CCE2-6D32-EB48-0CB792290C5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80FBFAAF-C13C-5335-78F1-E24B272C64A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81DDF44-EF8A-599D-66F4-DBB01F5E2C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3B886-21B2-42C9-A4E4-051C6F5F6BA4}" type="datetimeFigureOut">
              <a:rPr lang="zh-CN" altLang="en-US" smtClean="0"/>
              <a:t>2024/10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62216CF-13EF-5E7C-1802-2A1653130A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8B04DF0-77C0-ACB9-BCA4-111B97B580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8131E7-4AD6-4149-A9F6-4FC45BB79F4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59356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A1B7EB8-E1E8-A2D9-E155-BB98321220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3A407C1-6561-0AA1-CB89-F2B238F8E3A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F0670E3-1F0F-D119-6A3C-6BFC216A0E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3B886-21B2-42C9-A4E4-051C6F5F6BA4}" type="datetimeFigureOut">
              <a:rPr lang="zh-CN" altLang="en-US" smtClean="0"/>
              <a:t>2024/10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DE736F6-9786-824D-BBBE-052CFA7AF2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33C1AA6-3F46-CEF5-5DC4-CD3D0E4BD2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8131E7-4AD6-4149-A9F6-4FC45BB79F4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9647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45BEE100-6362-1681-E800-94C827BB348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D093DAE-BC86-75DF-A141-CBD494156C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9B95258-9FF7-CC9B-D6BB-CEE098B9FF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3B886-21B2-42C9-A4E4-051C6F5F6BA4}" type="datetimeFigureOut">
              <a:rPr lang="zh-CN" altLang="en-US" smtClean="0"/>
              <a:t>2024/10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E103547-54F4-B01E-A19E-975C178F31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360BA7D-D068-FDD2-C3C2-121F332E6B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8131E7-4AD6-4149-A9F6-4FC45BB79F4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93237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0746B5C-EB74-124D-E7E4-F49F63CC33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A961C2D-57BB-2B91-44B5-A919C266884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DECF459-6614-9E73-D268-5568B90D94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3B886-21B2-42C9-A4E4-051C6F5F6BA4}" type="datetimeFigureOut">
              <a:rPr lang="zh-CN" altLang="en-US" smtClean="0"/>
              <a:t>2024/10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694430A-97BA-2C6C-645B-CF1BB1537D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9B4B3AE-A7C7-F75B-0659-0D104048A7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8131E7-4AD6-4149-A9F6-4FC45BB79F4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154159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446EB90-F39C-3244-F318-34D74E8EA1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56AA708-D99B-DCF7-27C1-E2836BFDB27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56471D3-0B5D-FDDD-3389-C3A685F222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3B886-21B2-42C9-A4E4-051C6F5F6BA4}" type="datetimeFigureOut">
              <a:rPr lang="zh-CN" altLang="en-US" smtClean="0"/>
              <a:t>2024/10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E7FDD81-932B-F841-CC88-1749E072CD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8161683-F075-F94C-155A-60D2F3FDA3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8131E7-4AD6-4149-A9F6-4FC45BB79F4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24472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9725017-3344-CCB5-F1FC-DCA55DED28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F56D498-F664-8396-E089-01F92615625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13450AD-B4DE-E222-8C6E-640DCDA717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537D8B2-9D4E-805C-3E96-3781E1AAF6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3B886-21B2-42C9-A4E4-051C6F5F6BA4}" type="datetimeFigureOut">
              <a:rPr lang="zh-CN" altLang="en-US" smtClean="0"/>
              <a:t>2024/10/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60DDFD0-7536-D2F6-3BC8-152984C3BD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21EB338-F19A-2384-8905-EA0D4A85EC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8131E7-4AD6-4149-A9F6-4FC45BB79F4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370823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33CD573-9C9F-9484-CE7D-BB172AC515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B4F6CEA-5EEC-F8B2-F82F-44E1961529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5A97317-0463-CB94-380A-06382D3C9A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621E6461-766F-880C-3F04-90233499040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8929985C-8EE5-B280-5179-EACE5A905FF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3FAE771B-011A-387D-20A7-A1862A241C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3B886-21B2-42C9-A4E4-051C6F5F6BA4}" type="datetimeFigureOut">
              <a:rPr lang="zh-CN" altLang="en-US" smtClean="0"/>
              <a:t>2024/10/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C7F2F2D6-3303-F05A-6C0D-581BC46817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39B67ED-62FC-CB35-B92C-0C070AF46E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8131E7-4AD6-4149-A9F6-4FC45BB79F4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29401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0F81D59-200B-C4A9-059A-2182E6E9A8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F4853559-71F8-B0C6-BC1D-06DD667341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3B886-21B2-42C9-A4E4-051C6F5F6BA4}" type="datetimeFigureOut">
              <a:rPr lang="zh-CN" altLang="en-US" smtClean="0"/>
              <a:t>2024/10/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B72540A9-A01C-D07E-5881-9A6C9B6CCA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4061C8CB-6A3F-CF7D-27E3-B81CBDC5DD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8131E7-4AD6-4149-A9F6-4FC45BB79F4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60372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2393B7AA-47B8-3F0A-6067-6C8FE23670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3B886-21B2-42C9-A4E4-051C6F5F6BA4}" type="datetimeFigureOut">
              <a:rPr lang="zh-CN" altLang="en-US" smtClean="0"/>
              <a:t>2024/10/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C7C6D131-24FA-1CC6-5429-F6D91DAE6A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70ED80A0-2F58-1FB4-4CA0-DB01C483B1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8131E7-4AD6-4149-A9F6-4FC45BB79F4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63515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E0E00FB-4A62-EF29-3D25-B12EBE0413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660969E-E891-1F1C-3EB8-0AFC997FAA5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5362D20-F58D-8ACA-5632-9B0E610575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26B9BFF-CC04-48C8-1E0A-30BAF455F9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3B886-21B2-42C9-A4E4-051C6F5F6BA4}" type="datetimeFigureOut">
              <a:rPr lang="zh-CN" altLang="en-US" smtClean="0"/>
              <a:t>2024/10/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A34051E-5EAC-F4F8-F47D-9A122EB342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4F7023A-A01B-F034-0D2D-07BB5E0377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8131E7-4AD6-4149-A9F6-4FC45BB79F4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96692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6252F00-AAF8-B745-365F-C4C78F97BC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B79EA6DD-540C-CD5B-D2E0-96B6570A976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623B9C4-2106-A7CB-FB4C-BAE71FBE73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50B54D0-EEF6-5A8F-5C96-3E7314E51F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3B886-21B2-42C9-A4E4-051C6F5F6BA4}" type="datetimeFigureOut">
              <a:rPr lang="zh-CN" altLang="en-US" smtClean="0"/>
              <a:t>2024/10/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F24F838-148A-5E0A-BF8B-A9DA872AC7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DC6E445-E371-2EAE-8D41-69E0CA9901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8131E7-4AD6-4149-A9F6-4FC45BB79F4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34487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95907D93-9A77-B022-EF0C-91CA642AE1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84F7CA8-6FE5-DEA2-61C1-7790BBA2A8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A29D82B-9F86-4E07-5D10-F0BAF644C6F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B3B886-21B2-42C9-A4E4-051C6F5F6BA4}" type="datetimeFigureOut">
              <a:rPr lang="zh-CN" altLang="en-US" smtClean="0"/>
              <a:t>2024/10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A7BB1D1-5DF0-AFF9-0BCF-575E6685CC2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8D442E6-6EC2-6B9C-937C-19DC065052C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8131E7-4AD6-4149-A9F6-4FC45BB79F4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8259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0FB43ABC-4F9B-9F61-DD46-8DD02C8E98C0}"/>
              </a:ext>
            </a:extLst>
          </p:cNvPr>
          <p:cNvSpPr txBox="1"/>
          <p:nvPr/>
        </p:nvSpPr>
        <p:spPr>
          <a:xfrm>
            <a:off x="475784" y="1087077"/>
            <a:ext cx="11567531" cy="485312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240000"/>
              </a:lnSpc>
              <a:spcBef>
                <a:spcPts val="1700"/>
              </a:spcBef>
              <a:spcAft>
                <a:spcPts val="1650"/>
              </a:spcAft>
            </a:pPr>
            <a:r>
              <a:rPr lang="en-US" altLang="zh-CN" sz="2400" b="1" i="1" kern="22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Comparison of Adjuvant Treatment Regimens for High-Risk Hepatocellular Carcinoma: A Bayesian Network Meta-Analysis and Systematic Review</a:t>
            </a:r>
            <a:endParaRPr lang="zh-CN" altLang="zh-CN" sz="2400" b="1" i="1" kern="2200" dirty="0">
              <a:effectLst/>
              <a:latin typeface="等线" panose="02010600030101010101" pitchFamily="2" charset="-122"/>
              <a:ea typeface="等线" panose="02010600030101010101" pitchFamily="2" charset="-122"/>
            </a:endParaRPr>
          </a:p>
          <a:p>
            <a:pPr algn="just">
              <a:lnSpc>
                <a:spcPct val="200000"/>
              </a:lnSpc>
            </a:pPr>
            <a:r>
              <a:rPr lang="en-GB" altLang="zh-CN" sz="1600" kern="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Jiahao</a:t>
            </a:r>
            <a:r>
              <a:rPr lang="en-GB" altLang="zh-CN" sz="1600" kern="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Li </a:t>
            </a:r>
            <a:r>
              <a:rPr lang="en-GB" altLang="zh-CN" sz="1600" kern="0" baseline="300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GB" altLang="zh-CN" sz="1600" kern="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GB" altLang="zh-CN" sz="1600" kern="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Yingnan</a:t>
            </a:r>
            <a:r>
              <a:rPr lang="en-GB" altLang="zh-CN" sz="1600" kern="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Liu </a:t>
            </a:r>
            <a:r>
              <a:rPr lang="en-GB" altLang="zh-CN" sz="1600" kern="0" baseline="300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GB" altLang="zh-CN" sz="1600" kern="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GB" altLang="zh-CN" sz="1600" kern="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Yuqi</a:t>
            </a:r>
            <a:r>
              <a:rPr lang="en-GB" altLang="zh-CN" sz="1600" kern="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Qiu</a:t>
            </a:r>
            <a:r>
              <a:rPr lang="en-GB" altLang="zh-CN" sz="1600" kern="0" baseline="300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a</a:t>
            </a:r>
            <a:r>
              <a:rPr lang="en-GB" altLang="zh-CN" sz="1600" kern="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Chao Qu </a:t>
            </a:r>
            <a:r>
              <a:rPr lang="en-GB" altLang="zh-CN" sz="1600" kern="0" baseline="300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GB" altLang="zh-CN" sz="1600" kern="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GB" altLang="zh-CN" sz="1600" kern="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Jiarui</a:t>
            </a:r>
            <a:r>
              <a:rPr lang="en-GB" altLang="zh-CN" sz="1600" kern="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Li </a:t>
            </a:r>
            <a:r>
              <a:rPr lang="en-GB" altLang="zh-CN" sz="1600" kern="0" baseline="300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GB" altLang="zh-CN" sz="1600" kern="100" baseline="300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 </a:t>
            </a:r>
            <a:r>
              <a:rPr lang="en-GB" altLang="zh-CN" sz="16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Department of Interventional Therapy, The First Hospital of Jilin University, Changchun, Jilin Province, 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eople’s Republic of China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GB" altLang="zh-CN" sz="1600" kern="100" baseline="300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 </a:t>
            </a:r>
            <a:r>
              <a:rPr lang="en-GB" altLang="zh-CN" sz="16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Department of Radiology, The First Hospital of Jilin University, Changchun, Jilin Province, People’s Republic of China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</a:pPr>
            <a:r>
              <a:rPr lang="en-GB" altLang="zh-CN" sz="1600" kern="0" baseline="300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 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</a:pPr>
            <a:r>
              <a:rPr lang="en-GB" altLang="zh-CN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orresponding author: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GB" altLang="zh-CN" sz="1600" kern="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Jiarui</a:t>
            </a:r>
            <a:r>
              <a:rPr lang="en-GB" altLang="zh-CN" sz="1600" kern="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Li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GB" altLang="zh-CN" sz="16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Department of Interventional Therapy, The First Hospital of Jilin University, Changchun, Jilin Province, 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eople’s Republic of China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US" altLang="zh-CN" sz="16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E-mail address:</a:t>
            </a:r>
            <a:r>
              <a:rPr lang="en-US" altLang="zh-CN" sz="16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ljr@jlu.edu.cn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916872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72149DE7-DB17-604E-9446-4CDD5A2D9F64}"/>
              </a:ext>
            </a:extLst>
          </p:cNvPr>
          <p:cNvSpPr txBox="1"/>
          <p:nvPr/>
        </p:nvSpPr>
        <p:spPr>
          <a:xfrm>
            <a:off x="999066" y="1839427"/>
            <a:ext cx="10193867" cy="219701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ents</a:t>
            </a:r>
            <a:endParaRPr lang="en-US" altLang="zh-CN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 ---------------------</a:t>
            </a:r>
            <a:r>
              <a:rPr lang="en-GB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Methodological quality assessment of the included randomised controlled trials</a:t>
            </a: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  <a:p>
            <a:pPr>
              <a:lnSpc>
                <a:spcPct val="150000"/>
              </a:lnSpc>
            </a:pP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 ----------------------- Results of assessing the convergence of DFS’s network Meta-analysis model. </a:t>
            </a:r>
            <a:endParaRPr lang="zh-CN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 ---------------------Results of assessing the convergence of 1-DFS’s network Meta-analysis model. </a:t>
            </a:r>
            <a:endParaRPr lang="zh-CN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 ------------------------ Results of assessing the convergence of OS’s network Meta-analysis model.</a:t>
            </a:r>
          </a:p>
        </p:txBody>
      </p:sp>
    </p:spTree>
    <p:extLst>
      <p:ext uri="{BB962C8B-B14F-4D97-AF65-F5344CB8AC3E}">
        <p14:creationId xmlns:p14="http://schemas.microsoft.com/office/powerpoint/2010/main" val="10891009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>
            <a:extLst>
              <a:ext uri="{FF2B5EF4-FFF2-40B4-BE49-F238E27FC236}">
                <a16:creationId xmlns:a16="http://schemas.microsoft.com/office/drawing/2014/main" id="{4D6875A8-9980-94C6-5B43-E67788701471}"/>
              </a:ext>
            </a:extLst>
          </p:cNvPr>
          <p:cNvSpPr txBox="1"/>
          <p:nvPr/>
        </p:nvSpPr>
        <p:spPr>
          <a:xfrm>
            <a:off x="-1" y="0"/>
            <a:ext cx="11624733" cy="45807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: </a:t>
            </a:r>
            <a:r>
              <a:rPr lang="en-GB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Methodological quality assessment of the included randomised controlled trials</a:t>
            </a: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</p:txBody>
      </p:sp>
      <p:grpSp>
        <p:nvGrpSpPr>
          <p:cNvPr id="9" name="组合 8">
            <a:extLst>
              <a:ext uri="{FF2B5EF4-FFF2-40B4-BE49-F238E27FC236}">
                <a16:creationId xmlns:a16="http://schemas.microsoft.com/office/drawing/2014/main" id="{0AACB7B6-7401-EEA4-FDD0-78C1ED6B3900}"/>
              </a:ext>
            </a:extLst>
          </p:cNvPr>
          <p:cNvGrpSpPr/>
          <p:nvPr/>
        </p:nvGrpSpPr>
        <p:grpSpPr>
          <a:xfrm>
            <a:off x="1820332" y="319905"/>
            <a:ext cx="11624733" cy="6218189"/>
            <a:chOff x="2362199" y="458074"/>
            <a:chExt cx="11624733" cy="6218189"/>
          </a:xfrm>
        </p:grpSpPr>
        <p:grpSp>
          <p:nvGrpSpPr>
            <p:cNvPr id="4" name="组合 3">
              <a:extLst>
                <a:ext uri="{FF2B5EF4-FFF2-40B4-BE49-F238E27FC236}">
                  <a16:creationId xmlns:a16="http://schemas.microsoft.com/office/drawing/2014/main" id="{239C150F-A9BD-F64B-0D07-9B95E4EA8CA3}"/>
                </a:ext>
              </a:extLst>
            </p:cNvPr>
            <p:cNvGrpSpPr/>
            <p:nvPr/>
          </p:nvGrpSpPr>
          <p:grpSpPr>
            <a:xfrm>
              <a:off x="3097103" y="458074"/>
              <a:ext cx="5997793" cy="6218189"/>
              <a:chOff x="1574299" y="-434109"/>
              <a:chExt cx="8594937" cy="8940813"/>
            </a:xfrm>
          </p:grpSpPr>
          <p:pic>
            <p:nvPicPr>
              <p:cNvPr id="5" name="图片 4">
                <a:extLst>
                  <a:ext uri="{FF2B5EF4-FFF2-40B4-BE49-F238E27FC236}">
                    <a16:creationId xmlns:a16="http://schemas.microsoft.com/office/drawing/2014/main" id="{0BF953FF-4065-CC14-0B29-39ED23B4CDA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460" t="11377" r="6838" b="17599"/>
              <a:stretch/>
            </p:blipFill>
            <p:spPr>
              <a:xfrm>
                <a:off x="1574299" y="-434109"/>
                <a:ext cx="8594935" cy="4221019"/>
              </a:xfrm>
              <a:prstGeom prst="rect">
                <a:avLst/>
              </a:prstGeom>
            </p:spPr>
          </p:pic>
          <p:pic>
            <p:nvPicPr>
              <p:cNvPr id="3" name="图片 2">
                <a:extLst>
                  <a:ext uri="{FF2B5EF4-FFF2-40B4-BE49-F238E27FC236}">
                    <a16:creationId xmlns:a16="http://schemas.microsoft.com/office/drawing/2014/main" id="{C02E91BE-9657-8D55-8D3C-962E664521D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>
              <a:xfrm>
                <a:off x="1574300" y="3953189"/>
                <a:ext cx="8594936" cy="4553515"/>
              </a:xfrm>
              <a:prstGeom prst="rect">
                <a:avLst/>
              </a:prstGeom>
            </p:spPr>
          </p:pic>
        </p:grp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541729D3-EE60-0BC9-388A-4F2687FEDE8B}"/>
                </a:ext>
              </a:extLst>
            </p:cNvPr>
            <p:cNvSpPr txBox="1"/>
            <p:nvPr/>
          </p:nvSpPr>
          <p:spPr>
            <a:xfrm>
              <a:off x="2362199" y="687111"/>
              <a:ext cx="11624733" cy="33611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ssessor1: </a:t>
              </a:r>
              <a:r>
                <a:rPr lang="en-US" altLang="zh-CN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Jiahao</a:t>
              </a:r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Li</a:t>
              </a: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57447F59-AC47-404F-3F52-143DF2E9EEB4}"/>
                </a:ext>
              </a:extLst>
            </p:cNvPr>
            <p:cNvSpPr txBox="1"/>
            <p:nvPr/>
          </p:nvSpPr>
          <p:spPr>
            <a:xfrm>
              <a:off x="2362199" y="4185961"/>
              <a:ext cx="11624733" cy="33611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ssessor2: </a:t>
              </a:r>
              <a:r>
                <a:rPr lang="en-US" altLang="zh-CN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Yingnan</a:t>
              </a:r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Liu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1171952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79F40425-7056-357A-B83D-60C3181C3D4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3405" y="656063"/>
            <a:ext cx="8008434" cy="6201937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D13018CF-D9F0-6FDD-97BF-244875B9A670}"/>
              </a:ext>
            </a:extLst>
          </p:cNvPr>
          <p:cNvSpPr txBox="1"/>
          <p:nvPr/>
        </p:nvSpPr>
        <p:spPr>
          <a:xfrm>
            <a:off x="-1" y="0"/>
            <a:ext cx="1166095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 </a:t>
            </a: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A: Results of the Gelman-Rubin test for the DFS net meta-analysis model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1741054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组合 7">
            <a:extLst>
              <a:ext uri="{FF2B5EF4-FFF2-40B4-BE49-F238E27FC236}">
                <a16:creationId xmlns:a16="http://schemas.microsoft.com/office/drawing/2014/main" id="{5886E226-6E7C-28EB-8496-F97184EF959F}"/>
              </a:ext>
            </a:extLst>
          </p:cNvPr>
          <p:cNvGrpSpPr/>
          <p:nvPr/>
        </p:nvGrpSpPr>
        <p:grpSpPr>
          <a:xfrm>
            <a:off x="312234" y="562748"/>
            <a:ext cx="11572026" cy="5786013"/>
            <a:chOff x="1648522" y="-163010"/>
            <a:chExt cx="13716000" cy="6858000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2FDB6170-D5F8-1C71-D435-AA33BFCCC65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48522" y="-163010"/>
              <a:ext cx="6858000" cy="6858000"/>
            </a:xfrm>
            <a:prstGeom prst="rect">
              <a:avLst/>
            </a:prstGeom>
          </p:spPr>
        </p:pic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0CFCDB04-4628-0FB5-6E4E-A067A048CBC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506522" y="-163010"/>
              <a:ext cx="6858000" cy="6858000"/>
            </a:xfrm>
            <a:prstGeom prst="rect">
              <a:avLst/>
            </a:prstGeom>
          </p:spPr>
        </p:pic>
      </p:grpSp>
      <p:sp>
        <p:nvSpPr>
          <p:cNvPr id="9" name="文本框 8">
            <a:extLst>
              <a:ext uri="{FF2B5EF4-FFF2-40B4-BE49-F238E27FC236}">
                <a16:creationId xmlns:a16="http://schemas.microsoft.com/office/drawing/2014/main" id="{15352925-FCDD-53BC-EDBA-78AACC3C3CBB}"/>
              </a:ext>
            </a:extLst>
          </p:cNvPr>
          <p:cNvSpPr txBox="1"/>
          <p:nvPr/>
        </p:nvSpPr>
        <p:spPr>
          <a:xfrm>
            <a:off x="-1" y="0"/>
            <a:ext cx="1098222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 </a:t>
            </a: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B: Kernel density estimation plot and trace plot for DFS net meta-analysis model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2726383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B78E9BC5-7A51-CF39-19D7-AD5308C3E0E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8800" y="624468"/>
            <a:ext cx="7852319" cy="6233532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BBC1FD4F-BEC2-BDA3-6013-CB7055C6498C}"/>
              </a:ext>
            </a:extLst>
          </p:cNvPr>
          <p:cNvSpPr txBox="1"/>
          <p:nvPr/>
        </p:nvSpPr>
        <p:spPr>
          <a:xfrm>
            <a:off x="-1" y="0"/>
            <a:ext cx="1166095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 </a:t>
            </a: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A: Results of the Gelman-Rubin test for the 1-DFS net meta-analysis model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566036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组合 7">
            <a:extLst>
              <a:ext uri="{FF2B5EF4-FFF2-40B4-BE49-F238E27FC236}">
                <a16:creationId xmlns:a16="http://schemas.microsoft.com/office/drawing/2014/main" id="{C2AC1F1F-B9B2-D40A-F1F1-1A91D9177E37}"/>
              </a:ext>
            </a:extLst>
          </p:cNvPr>
          <p:cNvGrpSpPr/>
          <p:nvPr/>
        </p:nvGrpSpPr>
        <p:grpSpPr>
          <a:xfrm>
            <a:off x="525036" y="716465"/>
            <a:ext cx="11141927" cy="5570964"/>
            <a:chOff x="1410629" y="-20444"/>
            <a:chExt cx="13716000" cy="6858000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A0AA6E16-2A44-F739-E19E-1458F72DD43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10629" y="-20444"/>
              <a:ext cx="6858000" cy="6858000"/>
            </a:xfrm>
            <a:prstGeom prst="rect">
              <a:avLst/>
            </a:prstGeom>
          </p:spPr>
        </p:pic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17AA7171-AF13-7702-7383-21098D59698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268629" y="-20444"/>
              <a:ext cx="6858000" cy="6858000"/>
            </a:xfrm>
            <a:prstGeom prst="rect">
              <a:avLst/>
            </a:prstGeom>
          </p:spPr>
        </p:pic>
      </p:grpSp>
      <p:sp>
        <p:nvSpPr>
          <p:cNvPr id="9" name="文本框 8">
            <a:extLst>
              <a:ext uri="{FF2B5EF4-FFF2-40B4-BE49-F238E27FC236}">
                <a16:creationId xmlns:a16="http://schemas.microsoft.com/office/drawing/2014/main" id="{30E03542-FE11-0CA6-E5A7-EE6D801F03D3}"/>
              </a:ext>
            </a:extLst>
          </p:cNvPr>
          <p:cNvSpPr txBox="1"/>
          <p:nvPr/>
        </p:nvSpPr>
        <p:spPr>
          <a:xfrm>
            <a:off x="-1" y="0"/>
            <a:ext cx="1098222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 </a:t>
            </a: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B: Kernel density estimation plot and trace plot for 1-DFS net meta-analysis model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7685260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33B0B294-B7D7-89E1-575B-A67C57FB6BB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36955" y="767575"/>
            <a:ext cx="7872762" cy="6090425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D3A56D91-9EA7-E2E6-932F-571C9224FFD9}"/>
              </a:ext>
            </a:extLst>
          </p:cNvPr>
          <p:cNvSpPr txBox="1"/>
          <p:nvPr/>
        </p:nvSpPr>
        <p:spPr>
          <a:xfrm>
            <a:off x="-1" y="0"/>
            <a:ext cx="1166095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 </a:t>
            </a: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A: Results of the Gelman-Rubin test for the OS net meta-analysis model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5267148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组合 7">
            <a:extLst>
              <a:ext uri="{FF2B5EF4-FFF2-40B4-BE49-F238E27FC236}">
                <a16:creationId xmlns:a16="http://schemas.microsoft.com/office/drawing/2014/main" id="{A2074FB7-3F14-D090-B6FA-23A7189416FC}"/>
              </a:ext>
            </a:extLst>
          </p:cNvPr>
          <p:cNvGrpSpPr/>
          <p:nvPr/>
        </p:nvGrpSpPr>
        <p:grpSpPr>
          <a:xfrm>
            <a:off x="492873" y="627436"/>
            <a:ext cx="11206253" cy="5603127"/>
            <a:chOff x="1090961" y="0"/>
            <a:chExt cx="13716000" cy="6858000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7F8428A3-375F-24BF-7126-AA91D724F9B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90961" y="0"/>
              <a:ext cx="6858000" cy="6858000"/>
            </a:xfrm>
            <a:prstGeom prst="rect">
              <a:avLst/>
            </a:prstGeom>
          </p:spPr>
        </p:pic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DE5F4C8F-F4D7-327F-B8C8-277B3FE6006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48961" y="0"/>
              <a:ext cx="6858000" cy="6858000"/>
            </a:xfrm>
            <a:prstGeom prst="rect">
              <a:avLst/>
            </a:prstGeom>
          </p:spPr>
        </p:pic>
      </p:grpSp>
      <p:sp>
        <p:nvSpPr>
          <p:cNvPr id="9" name="文本框 8">
            <a:extLst>
              <a:ext uri="{FF2B5EF4-FFF2-40B4-BE49-F238E27FC236}">
                <a16:creationId xmlns:a16="http://schemas.microsoft.com/office/drawing/2014/main" id="{3FE789A7-93D4-C16D-387B-8A1160B10893}"/>
              </a:ext>
            </a:extLst>
          </p:cNvPr>
          <p:cNvSpPr txBox="1"/>
          <p:nvPr/>
        </p:nvSpPr>
        <p:spPr>
          <a:xfrm>
            <a:off x="-1" y="0"/>
            <a:ext cx="1098222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 </a:t>
            </a: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B: Kernel density estimation plot and trace plot for OS net meta-analysis model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861268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6</TotalTime>
  <Words>292</Words>
  <Application>Microsoft Office PowerPoint</Application>
  <PresentationFormat>宽屏</PresentationFormat>
  <Paragraphs>23</Paragraphs>
  <Slides>9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9</vt:i4>
      </vt:variant>
    </vt:vector>
  </HeadingPairs>
  <TitlesOfParts>
    <vt:vector size="14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家豪 李</dc:creator>
  <cp:lastModifiedBy>家豪 李</cp:lastModifiedBy>
  <cp:revision>6</cp:revision>
  <dcterms:created xsi:type="dcterms:W3CDTF">2024-08-18T06:43:35Z</dcterms:created>
  <dcterms:modified xsi:type="dcterms:W3CDTF">2024-10-04T08:01:52Z</dcterms:modified>
</cp:coreProperties>
</file>